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79" d="100"/>
          <a:sy n="79" d="100"/>
        </p:scale>
        <p:origin x="-230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0BEBF6F-AB8A-D848-9E08-5C99DAB0BF8D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F41784A-855D-C446-AD80-582F401D3F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04968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F41784A-855D-C446-AD80-582F401D3FA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27587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32E8-BC2F-ED4D-89F8-E35C35068FD8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5917D-D8DB-B546-9E1C-198F29DD9D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57173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32E8-BC2F-ED4D-89F8-E35C35068FD8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5917D-D8DB-B546-9E1C-198F29DD9D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54051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32E8-BC2F-ED4D-89F8-E35C35068FD8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5917D-D8DB-B546-9E1C-198F29DD9D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2162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32E8-BC2F-ED4D-89F8-E35C35068FD8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5917D-D8DB-B546-9E1C-198F29DD9D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01267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32E8-BC2F-ED4D-89F8-E35C35068FD8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5917D-D8DB-B546-9E1C-198F29DD9D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91140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32E8-BC2F-ED4D-89F8-E35C35068FD8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5917D-D8DB-B546-9E1C-198F29DD9D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41119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32E8-BC2F-ED4D-89F8-E35C35068FD8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5917D-D8DB-B546-9E1C-198F29DD9D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36318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32E8-BC2F-ED4D-89F8-E35C35068FD8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5917D-D8DB-B546-9E1C-198F29DD9D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87326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32E8-BC2F-ED4D-89F8-E35C35068FD8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5917D-D8DB-B546-9E1C-198F29DD9D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88535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32E8-BC2F-ED4D-89F8-E35C35068FD8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5917D-D8DB-B546-9E1C-198F29DD9D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03973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32E8-BC2F-ED4D-89F8-E35C35068FD8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5917D-D8DB-B546-9E1C-198F29DD9D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35303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9F32E8-BC2F-ED4D-89F8-E35C35068FD8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35917D-D8DB-B546-9E1C-198F29DD9D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58827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958"/>
          <a:stretch/>
        </p:blipFill>
        <p:spPr bwMode="auto">
          <a:xfrm>
            <a:off x="203199" y="237069"/>
            <a:ext cx="8771467" cy="6016109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Rectangle 2"/>
          <p:cNvSpPr/>
          <p:nvPr/>
        </p:nvSpPr>
        <p:spPr>
          <a:xfrm>
            <a:off x="0" y="6275969"/>
            <a:ext cx="8974666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 smtClean="0"/>
              <a:t>Additional file 13. Analysis </a:t>
            </a:r>
            <a:r>
              <a:rPr lang="en-US" sz="1400" dirty="0"/>
              <a:t>workflow followed for assembling illumina and PacBio sequence reads of HR-12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7050308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19</Words>
  <Application>Microsoft Macintosh PowerPoint</Application>
  <PresentationFormat>On-screen Show (4:3)</PresentationFormat>
  <Paragraphs>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ahesh.hb@rediffmail.co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hesh H B</dc:creator>
  <cp:lastModifiedBy>Mahesh H B</cp:lastModifiedBy>
  <cp:revision>3</cp:revision>
  <dcterms:created xsi:type="dcterms:W3CDTF">2015-11-03T05:50:20Z</dcterms:created>
  <dcterms:modified xsi:type="dcterms:W3CDTF">2016-01-03T17:34:09Z</dcterms:modified>
</cp:coreProperties>
</file>